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4" roundtripDataSignature="AMtx7mgZHY/Qy1aJxIv/Inx5c/+yOfE6C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77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customschemas.google.com/relationships/presentationmetadata" Target="metadata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Google Shape;175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76" name="Google Shape;176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77" name="Google Shape;177;p1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0</a:t>
            </a:fld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86" name="Google Shape;186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7" name="Google Shape;187;p1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1</a:t>
            </a:fld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96" name="Google Shape;196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7" name="Google Shape;197;p1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2</a:t>
            </a:fld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Google Shape;205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06" name="Google Shape;206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7" name="Google Shape;207;p1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3</a:t>
            </a:fld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Google Shape;215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16" name="Google Shape;216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7" name="Google Shape;217;p1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4</a:t>
            </a:fld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Google Shape;225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26" name="Google Shape;226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7" name="Google Shape;227;p1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5</a:t>
            </a:fld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Google Shape;235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36" name="Google Shape;236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7" name="Google Shape;237;p1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6</a:t>
            </a:fld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Google Shape;245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46" name="Google Shape;246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7" name="Google Shape;247;p1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7</a:t>
            </a:fld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56" name="Google Shape;256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7" name="Google Shape;257;p1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8</a:t>
            </a:fld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Google Shape;265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66" name="Google Shape;266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7" name="Google Shape;267;p1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9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6" name="Google Shape;96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Google Shape;97;p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2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6" name="Google Shape;106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7" name="Google Shape;107;p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Google Shape;115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6" name="Google Shape;116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7" name="Google Shape;117;p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6" name="Google Shape;126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7" name="Google Shape;127;p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5</a:t>
            </a:fld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6" name="Google Shape;136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7" name="Google Shape;137;p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6" name="Google Shape;146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7" name="Google Shape;147;p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7</a:t>
            </a:fld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Google Shape;155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56" name="Google Shape;156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7" name="Google Shape;157;p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8</a:t>
            </a:fld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66" name="Google Shape;166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7" name="Google Shape;167;p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9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1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1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3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30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3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3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31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31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3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3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3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2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2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2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3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3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4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5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5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25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5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25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8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8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8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2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9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9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2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5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9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3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1"/>
          <p:cNvSpPr txBox="1"/>
          <p:nvPr/>
        </p:nvSpPr>
        <p:spPr>
          <a:xfrm>
            <a:off x="1823953" y="1026367"/>
            <a:ext cx="248946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) GSE6575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0" name="Google Shape;90;p1"/>
          <p:cNvSpPr txBox="1"/>
          <p:nvPr/>
        </p:nvSpPr>
        <p:spPr>
          <a:xfrm>
            <a:off x="4888164" y="370277"/>
            <a:ext cx="1596611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1" name="Google Shape;91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3187" y="1795926"/>
            <a:ext cx="5617125" cy="4151991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Google Shape;92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84775" y="1643084"/>
            <a:ext cx="5381042" cy="4304833"/>
          </a:xfrm>
          <a:prstGeom prst="rect">
            <a:avLst/>
          </a:prstGeom>
          <a:noFill/>
          <a:ln>
            <a:noFill/>
          </a:ln>
        </p:spPr>
      </p:pic>
      <p:sp>
        <p:nvSpPr>
          <p:cNvPr id="93" name="Google Shape;93;p1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Google Shape;179;p10"/>
          <p:cNvSpPr txBox="1"/>
          <p:nvPr/>
        </p:nvSpPr>
        <p:spPr>
          <a:xfrm>
            <a:off x="1823953" y="1026367"/>
            <a:ext cx="255198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j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0" name="Google Shape;180;p10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1" name="Google Shape;181;p10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82" name="Google Shape;182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81891" y="2481942"/>
            <a:ext cx="5263097" cy="2732973"/>
          </a:xfrm>
          <a:prstGeom prst="rect">
            <a:avLst/>
          </a:prstGeom>
          <a:noFill/>
          <a:ln>
            <a:noFill/>
          </a:ln>
        </p:spPr>
      </p:pic>
      <p:sp>
        <p:nvSpPr>
          <p:cNvPr id="183" name="Google Shape;183;p10"/>
          <p:cNvSpPr txBox="1"/>
          <p:nvPr/>
        </p:nvSpPr>
        <p:spPr>
          <a:xfrm>
            <a:off x="6863938" y="2291938"/>
            <a:ext cx="4488872" cy="10156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 results</a:t>
            </a:r>
            <a:endParaRPr sz="6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p11"/>
          <p:cNvSpPr txBox="1"/>
          <p:nvPr/>
        </p:nvSpPr>
        <p:spPr>
          <a:xfrm>
            <a:off x="1823953" y="1026367"/>
            <a:ext cx="456706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) GSE53987_HP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0" name="Google Shape;190;p11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1" name="Google Shape;191;p11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92" name="Google Shape;192;p1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26183" y="2378546"/>
            <a:ext cx="4761124" cy="2472313"/>
          </a:xfrm>
          <a:prstGeom prst="rect">
            <a:avLst/>
          </a:prstGeom>
          <a:noFill/>
          <a:ln>
            <a:noFill/>
          </a:ln>
        </p:spPr>
      </p:pic>
      <p:pic>
        <p:nvPicPr>
          <p:cNvPr id="193" name="Google Shape;193;p1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78616" y="1366601"/>
            <a:ext cx="5392948" cy="431435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12"/>
          <p:cNvSpPr txBox="1"/>
          <p:nvPr/>
        </p:nvSpPr>
        <p:spPr>
          <a:xfrm>
            <a:off x="1823953" y="1026367"/>
            <a:ext cx="399192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) GSE53987_HP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0" name="Google Shape;200;p12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1" name="Google Shape;201;p12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2" name="Google Shape;202;p1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26183" y="2361776"/>
            <a:ext cx="5581403" cy="289826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3" name="Google Shape;203;p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198919" y="1638810"/>
            <a:ext cx="5430239" cy="434419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Google Shape;209;p13"/>
          <p:cNvSpPr txBox="1"/>
          <p:nvPr/>
        </p:nvSpPr>
        <p:spPr>
          <a:xfrm>
            <a:off x="1823953" y="1026367"/>
            <a:ext cx="410234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) GSE53987_HP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0" name="Google Shape;210;p13"/>
          <p:cNvSpPr txBox="1"/>
          <p:nvPr/>
        </p:nvSpPr>
        <p:spPr>
          <a:xfrm>
            <a:off x="4888164" y="370277"/>
            <a:ext cx="305846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pre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1" name="Google Shape;211;p13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12" name="Google Shape;212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15636" y="2232580"/>
            <a:ext cx="5082639" cy="2639266"/>
          </a:xfrm>
          <a:prstGeom prst="rect">
            <a:avLst/>
          </a:prstGeom>
          <a:noFill/>
          <a:ln>
            <a:noFill/>
          </a:ln>
        </p:spPr>
      </p:pic>
      <p:sp>
        <p:nvSpPr>
          <p:cNvPr id="213" name="Google Shape;213;p13"/>
          <p:cNvSpPr txBox="1"/>
          <p:nvPr/>
        </p:nvSpPr>
        <p:spPr>
          <a:xfrm>
            <a:off x="6282047" y="2660073"/>
            <a:ext cx="4773880" cy="10156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 results</a:t>
            </a:r>
            <a:endParaRPr sz="6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14"/>
          <p:cNvSpPr txBox="1"/>
          <p:nvPr/>
        </p:nvSpPr>
        <p:spPr>
          <a:xfrm>
            <a:off x="1823953" y="1026367"/>
            <a:ext cx="494789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0" name="Google Shape;220;p14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1" name="Google Shape;221;p14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2" name="Google Shape;222;p1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92878" y="2421638"/>
            <a:ext cx="4888164" cy="2538281"/>
          </a:xfrm>
          <a:prstGeom prst="rect">
            <a:avLst/>
          </a:prstGeom>
          <a:noFill/>
          <a:ln>
            <a:noFill/>
          </a:ln>
        </p:spPr>
      </p:pic>
      <p:pic>
        <p:nvPicPr>
          <p:cNvPr id="223" name="Google Shape;223;p1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78616" y="1472597"/>
            <a:ext cx="5545453" cy="443636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Google Shape;229;p15"/>
          <p:cNvSpPr txBox="1"/>
          <p:nvPr/>
        </p:nvSpPr>
        <p:spPr>
          <a:xfrm>
            <a:off x="1823953" y="1026367"/>
            <a:ext cx="505830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0" name="Google Shape;230;p15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1" name="Google Shape;231;p15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2" name="Google Shape;232;p1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42935" y="1984313"/>
            <a:ext cx="5564291" cy="2889374"/>
          </a:xfrm>
          <a:prstGeom prst="rect">
            <a:avLst/>
          </a:prstGeom>
          <a:noFill/>
          <a:ln>
            <a:noFill/>
          </a:ln>
        </p:spPr>
      </p:pic>
      <p:pic>
        <p:nvPicPr>
          <p:cNvPr id="233" name="Google Shape;233;p1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846952" y="1474436"/>
            <a:ext cx="5841175" cy="467294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16"/>
          <p:cNvSpPr txBox="1"/>
          <p:nvPr/>
        </p:nvSpPr>
        <p:spPr>
          <a:xfrm>
            <a:off x="1823953" y="1026367"/>
            <a:ext cx="494789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) GSE53987_PFC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0" name="Google Shape;240;p16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1" name="Google Shape;241;p16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2" name="Google Shape;242;p1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51263" y="2185060"/>
            <a:ext cx="5770114" cy="2996252"/>
          </a:xfrm>
          <a:prstGeom prst="rect">
            <a:avLst/>
          </a:prstGeom>
          <a:noFill/>
          <a:ln>
            <a:noFill/>
          </a:ln>
        </p:spPr>
      </p:pic>
      <p:pic>
        <p:nvPicPr>
          <p:cNvPr id="243" name="Google Shape;243;p1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78616" y="1211033"/>
            <a:ext cx="5841175" cy="467294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17"/>
          <p:cNvSpPr txBox="1"/>
          <p:nvPr/>
        </p:nvSpPr>
        <p:spPr>
          <a:xfrm>
            <a:off x="1823953" y="1026367"/>
            <a:ext cx="356136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) GSE53987_STR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0" name="Google Shape;250;p17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1" name="Google Shape;251;p17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52" name="Google Shape;252;p1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88736" y="2503606"/>
            <a:ext cx="5035138" cy="2614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3" name="Google Shape;253;p1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59805" y="1480764"/>
            <a:ext cx="5407838" cy="432627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Google Shape;259;p18"/>
          <p:cNvSpPr txBox="1"/>
          <p:nvPr/>
        </p:nvSpPr>
        <p:spPr>
          <a:xfrm>
            <a:off x="1823953" y="1026367"/>
            <a:ext cx="356136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) GSE53987_STR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0" name="Google Shape;260;p18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1" name="Google Shape;261;p18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62" name="Google Shape;262;p1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17517" y="2814451"/>
            <a:ext cx="5365887" cy="2786349"/>
          </a:xfrm>
          <a:prstGeom prst="rect">
            <a:avLst/>
          </a:prstGeom>
          <a:noFill/>
          <a:ln>
            <a:noFill/>
          </a:ln>
        </p:spPr>
      </p:pic>
      <p:pic>
        <p:nvPicPr>
          <p:cNvPr id="263" name="Google Shape;263;p1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78615" y="1395699"/>
            <a:ext cx="5573545" cy="445883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Google Shape;269;p19"/>
          <p:cNvSpPr txBox="1"/>
          <p:nvPr/>
        </p:nvSpPr>
        <p:spPr>
          <a:xfrm>
            <a:off x="1823953" y="1026367"/>
            <a:ext cx="356136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) GSE53987_STR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0" name="Google Shape;270;p19"/>
          <p:cNvSpPr txBox="1"/>
          <p:nvPr/>
        </p:nvSpPr>
        <p:spPr>
          <a:xfrm>
            <a:off x="4888164" y="370277"/>
            <a:ext cx="302320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ajor Depressive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1" name="Google Shape;271;p19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72" name="Google Shape;272;p1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36099" y="2065438"/>
            <a:ext cx="5838720" cy="3031877"/>
          </a:xfrm>
          <a:prstGeom prst="rect">
            <a:avLst/>
          </a:prstGeom>
          <a:noFill/>
          <a:ln>
            <a:noFill/>
          </a:ln>
        </p:spPr>
      </p:pic>
      <p:pic>
        <p:nvPicPr>
          <p:cNvPr id="273" name="Google Shape;273;p1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97060" y="1102767"/>
            <a:ext cx="5524073" cy="441925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2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) GSE18123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0" name="Google Shape;100;p2"/>
          <p:cNvSpPr txBox="1"/>
          <p:nvPr/>
        </p:nvSpPr>
        <p:spPr>
          <a:xfrm>
            <a:off x="4888164" y="370277"/>
            <a:ext cx="1845145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1" name="Google Shape;101;p2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2" name="Google Shape;102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34390" y="2577604"/>
            <a:ext cx="4750130" cy="246660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" name="Google Shape;103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96000" y="1211283"/>
            <a:ext cx="5529848" cy="442387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3"/>
          <p:cNvSpPr txBox="1"/>
          <p:nvPr/>
        </p:nvSpPr>
        <p:spPr>
          <a:xfrm>
            <a:off x="1823953" y="1026367"/>
            <a:ext cx="285073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) GSE25507 GEO dataset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0" name="Google Shape;110;p3"/>
          <p:cNvSpPr txBox="1"/>
          <p:nvPr/>
        </p:nvSpPr>
        <p:spPr>
          <a:xfrm>
            <a:off x="4888164" y="370277"/>
            <a:ext cx="939681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utism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111;p3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2" name="Google Shape;112;p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27150" y="2307312"/>
            <a:ext cx="5791200" cy="300720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3" name="Google Shape;113;p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121275" y="1041463"/>
            <a:ext cx="5968849" cy="477507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4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) GSE17612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0" name="Google Shape;120;p4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1" name="Google Shape;121;p4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2" name="Google Shape;122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31273" y="2487380"/>
            <a:ext cx="5038296" cy="26162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3" name="Google Shape;123;p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134627" y="1026367"/>
            <a:ext cx="5469824" cy="437585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5"/>
          <p:cNvSpPr txBox="1"/>
          <p:nvPr/>
        </p:nvSpPr>
        <p:spPr>
          <a:xfrm>
            <a:off x="1823953" y="1026367"/>
            <a:ext cx="260808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) GSE62333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0" name="Google Shape;130;p5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1" name="Google Shape;131;p5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2" name="Google Shape;132;p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57282" y="2295589"/>
            <a:ext cx="5838718" cy="30318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33" name="Google Shape;133;p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40632" y="1211033"/>
            <a:ext cx="5494086" cy="439526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Google Shape;139;p6"/>
          <p:cNvSpPr txBox="1"/>
          <p:nvPr/>
        </p:nvSpPr>
        <p:spPr>
          <a:xfrm>
            <a:off x="1823953" y="1026367"/>
            <a:ext cx="245278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) GSE5389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0" name="Google Shape;140;p6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1" name="Google Shape;141;p6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42" name="Google Shape;142;p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548099"/>
            <a:ext cx="5391149" cy="2799466"/>
          </a:xfrm>
          <a:prstGeom prst="rect">
            <a:avLst/>
          </a:prstGeom>
          <a:noFill/>
          <a:ln>
            <a:noFill/>
          </a:ln>
        </p:spPr>
      </p:pic>
      <p:pic>
        <p:nvPicPr>
          <p:cNvPr id="143" name="Google Shape;143;p6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5695949" y="922787"/>
            <a:ext cx="6343650" cy="507492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p7"/>
          <p:cNvSpPr txBox="1"/>
          <p:nvPr/>
        </p:nvSpPr>
        <p:spPr>
          <a:xfrm>
            <a:off x="1823953" y="1026367"/>
            <a:ext cx="248465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) GSE7036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0" name="Google Shape;150;p7"/>
          <p:cNvSpPr txBox="1"/>
          <p:nvPr/>
        </p:nvSpPr>
        <p:spPr>
          <a:xfrm>
            <a:off x="4888164" y="370277"/>
            <a:ext cx="1917576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1" name="Google Shape;151;p7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52" name="Google Shape;152;p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8753" y="1746845"/>
            <a:ext cx="5541420" cy="2877498"/>
          </a:xfrm>
          <a:prstGeom prst="rect">
            <a:avLst/>
          </a:prstGeom>
          <a:noFill/>
          <a:ln>
            <a:noFill/>
          </a:ln>
        </p:spPr>
      </p:pic>
      <p:pic>
        <p:nvPicPr>
          <p:cNvPr id="153" name="Google Shape;153;p7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078616" y="1274595"/>
            <a:ext cx="5559136" cy="444730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8"/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0" name="Google Shape;160;p8"/>
          <p:cNvSpPr txBox="1"/>
          <p:nvPr/>
        </p:nvSpPr>
        <p:spPr>
          <a:xfrm>
            <a:off x="4888164" y="370277"/>
            <a:ext cx="1671420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hizophrenia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1" name="Google Shape;161;p8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62" name="Google Shape;162;p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26183" y="2333000"/>
            <a:ext cx="5632899" cy="2925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3" name="Google Shape;163;p8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346123" y="1026368"/>
            <a:ext cx="5453785" cy="436302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9"/>
          <p:cNvSpPr txBox="1"/>
          <p:nvPr/>
        </p:nvSpPr>
        <p:spPr>
          <a:xfrm>
            <a:off x="1823953" y="1026367"/>
            <a:ext cx="2548775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) GSE12654 GEO dataset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0" name="Google Shape;170;p9"/>
          <p:cNvSpPr txBox="1"/>
          <p:nvPr/>
        </p:nvSpPr>
        <p:spPr>
          <a:xfrm>
            <a:off x="4888164" y="370277"/>
            <a:ext cx="1893532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polar disorder</a:t>
            </a:r>
            <a:endParaRPr sz="20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1" name="Google Shape;171;p9"/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72" name="Google Shape;172;p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94852" y="1828800"/>
            <a:ext cx="5675894" cy="2947326"/>
          </a:xfrm>
          <a:prstGeom prst="rect">
            <a:avLst/>
          </a:prstGeom>
          <a:noFill/>
          <a:ln>
            <a:noFill/>
          </a:ln>
        </p:spPr>
      </p:pic>
      <p:pic>
        <p:nvPicPr>
          <p:cNvPr id="173" name="Google Shape;173;p9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221256" y="1260780"/>
            <a:ext cx="5098968" cy="407917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2</Words>
  <Application>Microsoft Office PowerPoint</Application>
  <PresentationFormat>Panorámica</PresentationFormat>
  <Paragraphs>78</Paragraphs>
  <Slides>19</Slides>
  <Notes>19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9</vt:i4>
      </vt:variant>
    </vt:vector>
  </HeadingPairs>
  <TitlesOfParts>
    <vt:vector size="22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Windows User</cp:lastModifiedBy>
  <cp:revision>1</cp:revision>
  <dcterms:created xsi:type="dcterms:W3CDTF">2024-05-16T14:56:22Z</dcterms:created>
  <dcterms:modified xsi:type="dcterms:W3CDTF">2024-10-16T10:32:13Z</dcterms:modified>
</cp:coreProperties>
</file>